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1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6035"/>
  </p:normalViewPr>
  <p:slideViewPr>
    <p:cSldViewPr snapToGrid="0">
      <p:cViewPr varScale="1">
        <p:scale>
          <a:sx n="66" d="100"/>
          <a:sy n="66" d="100"/>
        </p:scale>
        <p:origin x="3432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AE29D-2467-6B42-90BE-57E436D02AE9}" type="datetimeFigureOut">
              <a:rPr lang="en-US" smtClean="0"/>
              <a:t>7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48356-528F-784D-8A07-FF69842249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34052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AE29D-2467-6B42-90BE-57E436D02AE9}" type="datetimeFigureOut">
              <a:rPr lang="en-US" smtClean="0"/>
              <a:t>7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48356-528F-784D-8A07-FF69842249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09046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AE29D-2467-6B42-90BE-57E436D02AE9}" type="datetimeFigureOut">
              <a:rPr lang="en-US" smtClean="0"/>
              <a:t>7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48356-528F-784D-8A07-FF69842249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23136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AE29D-2467-6B42-90BE-57E436D02AE9}" type="datetimeFigureOut">
              <a:rPr lang="en-US" smtClean="0"/>
              <a:t>7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48356-528F-784D-8A07-FF69842249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94346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AE29D-2467-6B42-90BE-57E436D02AE9}" type="datetimeFigureOut">
              <a:rPr lang="en-US" smtClean="0"/>
              <a:t>7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48356-528F-784D-8A07-FF69842249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69362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AE29D-2467-6B42-90BE-57E436D02AE9}" type="datetimeFigureOut">
              <a:rPr lang="en-US" smtClean="0"/>
              <a:t>7/2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48356-528F-784D-8A07-FF69842249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95591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AE29D-2467-6B42-90BE-57E436D02AE9}" type="datetimeFigureOut">
              <a:rPr lang="en-US" smtClean="0"/>
              <a:t>7/24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48356-528F-784D-8A07-FF69842249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8115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AE29D-2467-6B42-90BE-57E436D02AE9}" type="datetimeFigureOut">
              <a:rPr lang="en-US" smtClean="0"/>
              <a:t>7/24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48356-528F-784D-8A07-FF69842249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55987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AE29D-2467-6B42-90BE-57E436D02AE9}" type="datetimeFigureOut">
              <a:rPr lang="en-US" smtClean="0"/>
              <a:t>7/24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48356-528F-784D-8A07-FF69842249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89623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AE29D-2467-6B42-90BE-57E436D02AE9}" type="datetimeFigureOut">
              <a:rPr lang="en-US" smtClean="0"/>
              <a:t>7/2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48356-528F-784D-8A07-FF69842249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27372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AE29D-2467-6B42-90BE-57E436D02AE9}" type="datetimeFigureOut">
              <a:rPr lang="en-US" smtClean="0"/>
              <a:t>7/2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48356-528F-784D-8A07-FF69842249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94987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DAE29D-2467-6B42-90BE-57E436D02AE9}" type="datetimeFigureOut">
              <a:rPr lang="en-US" smtClean="0"/>
              <a:t>7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248356-528F-784D-8A07-FF69842249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01963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>
            <a:extLst>
              <a:ext uri="{FF2B5EF4-FFF2-40B4-BE49-F238E27FC236}">
                <a16:creationId xmlns:a16="http://schemas.microsoft.com/office/drawing/2014/main" id="{DC326A92-FE85-8D6E-23BF-906AD9BC6B68}"/>
              </a:ext>
            </a:extLst>
          </p:cNvPr>
          <p:cNvGrpSpPr/>
          <p:nvPr/>
        </p:nvGrpSpPr>
        <p:grpSpPr>
          <a:xfrm>
            <a:off x="1218998" y="1487459"/>
            <a:ext cx="4216127" cy="2611744"/>
            <a:chOff x="2802369" y="4280242"/>
            <a:chExt cx="4216127" cy="2611744"/>
          </a:xfrm>
        </p:grpSpPr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7D9360B4-85B0-BC69-CCAA-AFF57226202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31" t="-1411" r="-4084" b="1351"/>
            <a:stretch/>
          </p:blipFill>
          <p:spPr>
            <a:xfrm>
              <a:off x="3195422" y="5412345"/>
              <a:ext cx="3548129" cy="1479641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84D660A0-1B94-C5FE-3F15-D193EEDFBF5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 contrast="40000"/>
                      </a14:imgEffect>
                    </a14:imgLayer>
                  </a14:imgProps>
                </a:ext>
              </a:extLst>
            </a:blip>
            <a:srcRect l="-9390" t="-157" r="12641" b="-8293"/>
            <a:stretch/>
          </p:blipFill>
          <p:spPr>
            <a:xfrm>
              <a:off x="2802369" y="4498247"/>
              <a:ext cx="4008939" cy="1003174"/>
            </a:xfrm>
            <a:prstGeom prst="rect">
              <a:avLst/>
            </a:prstGeom>
            <a:ln>
              <a:noFill/>
            </a:ln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1E77813C-59DA-A69C-2268-485A91510173}"/>
                </a:ext>
              </a:extLst>
            </p:cNvPr>
            <p:cNvSpPr txBox="1"/>
            <p:nvPr/>
          </p:nvSpPr>
          <p:spPr>
            <a:xfrm>
              <a:off x="6507536" y="4845765"/>
              <a:ext cx="510960" cy="207409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/>
                <a:t>UCP1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0C599228-E35D-4B39-8C60-3C6729000A68}"/>
                </a:ext>
              </a:extLst>
            </p:cNvPr>
            <p:cNvSpPr txBox="1"/>
            <p:nvPr/>
          </p:nvSpPr>
          <p:spPr>
            <a:xfrm>
              <a:off x="3784876" y="4280242"/>
              <a:ext cx="388561" cy="207409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/>
                <a:t>WT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53CE42F5-35E9-1AE2-E3B0-90B51A25510D}"/>
                </a:ext>
              </a:extLst>
            </p:cNvPr>
            <p:cNvSpPr txBox="1"/>
            <p:nvPr/>
          </p:nvSpPr>
          <p:spPr>
            <a:xfrm>
              <a:off x="5486256" y="4280242"/>
              <a:ext cx="383716" cy="246221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/>
                <a:t>KO  </a:t>
              </a:r>
            </a:p>
          </p:txBody>
        </p: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CCA29AC0-F408-211E-A9DB-143DCED8F594}"/>
              </a:ext>
            </a:extLst>
          </p:cNvPr>
          <p:cNvSpPr txBox="1"/>
          <p:nvPr/>
        </p:nvSpPr>
        <p:spPr>
          <a:xfrm>
            <a:off x="142299" y="179393"/>
            <a:ext cx="86893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l Fig. 5-source data 1 (bands used in the figure are highlighted in blue) 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04C95B20-F693-381D-4B3D-CE8B2A34402E}"/>
              </a:ext>
            </a:extLst>
          </p:cNvPr>
          <p:cNvSpPr txBox="1"/>
          <p:nvPr/>
        </p:nvSpPr>
        <p:spPr>
          <a:xfrm>
            <a:off x="142299" y="924122"/>
            <a:ext cx="1683884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b="1" dirty="0"/>
              <a:t>Supplemental Figure 5I. </a:t>
            </a:r>
          </a:p>
        </p:txBody>
      </p:sp>
      <p:sp>
        <p:nvSpPr>
          <p:cNvPr id="34" name="Left Arrow 33">
            <a:extLst>
              <a:ext uri="{FF2B5EF4-FFF2-40B4-BE49-F238E27FC236}">
                <a16:creationId xmlns:a16="http://schemas.microsoft.com/office/drawing/2014/main" id="{E1F6D1D6-3809-EC6B-D79D-17738A94C59F}"/>
              </a:ext>
            </a:extLst>
          </p:cNvPr>
          <p:cNvSpPr/>
          <p:nvPr/>
        </p:nvSpPr>
        <p:spPr>
          <a:xfrm>
            <a:off x="4788492" y="2086729"/>
            <a:ext cx="179795" cy="57772"/>
          </a:xfrm>
          <a:prstGeom prst="lef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24C97BB5-8597-F2BB-4583-920FE105DE51}"/>
              </a:ext>
            </a:extLst>
          </p:cNvPr>
          <p:cNvSpPr txBox="1"/>
          <p:nvPr/>
        </p:nvSpPr>
        <p:spPr>
          <a:xfrm>
            <a:off x="4949875" y="2236556"/>
            <a:ext cx="1166974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/>
              <a:t>Non-specific band</a:t>
            </a:r>
          </a:p>
        </p:txBody>
      </p:sp>
      <p:sp>
        <p:nvSpPr>
          <p:cNvPr id="36" name="Left Arrow 35">
            <a:extLst>
              <a:ext uri="{FF2B5EF4-FFF2-40B4-BE49-F238E27FC236}">
                <a16:creationId xmlns:a16="http://schemas.microsoft.com/office/drawing/2014/main" id="{5287B1AD-911C-E40B-CD97-ED1D40381A0A}"/>
              </a:ext>
            </a:extLst>
          </p:cNvPr>
          <p:cNvSpPr/>
          <p:nvPr/>
        </p:nvSpPr>
        <p:spPr>
          <a:xfrm rot="1093890">
            <a:off x="4781548" y="2285819"/>
            <a:ext cx="179795" cy="57771"/>
          </a:xfrm>
          <a:prstGeom prst="lef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 dirty="0"/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0EDA43E4-3502-5C73-719B-B37795CF66AE}"/>
              </a:ext>
            </a:extLst>
          </p:cNvPr>
          <p:cNvCxnSpPr>
            <a:cxnSpLocks/>
          </p:cNvCxnSpPr>
          <p:nvPr/>
        </p:nvCxnSpPr>
        <p:spPr>
          <a:xfrm>
            <a:off x="3345387" y="1820824"/>
            <a:ext cx="0" cy="226503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13BB34ED-E27F-A64E-FF00-F4A1675EEFA5}"/>
              </a:ext>
            </a:extLst>
          </p:cNvPr>
          <p:cNvSpPr txBox="1"/>
          <p:nvPr/>
        </p:nvSpPr>
        <p:spPr>
          <a:xfrm>
            <a:off x="4615345" y="3808747"/>
            <a:ext cx="637198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/>
              <a:t>β-Actin</a:t>
            </a:r>
          </a:p>
        </p:txBody>
      </p:sp>
      <p:sp>
        <p:nvSpPr>
          <p:cNvPr id="41" name="Left Arrow 40">
            <a:extLst>
              <a:ext uri="{FF2B5EF4-FFF2-40B4-BE49-F238E27FC236}">
                <a16:creationId xmlns:a16="http://schemas.microsoft.com/office/drawing/2014/main" id="{F639959E-3B58-1D9D-AC4C-19B4B9A27AAB}"/>
              </a:ext>
            </a:extLst>
          </p:cNvPr>
          <p:cNvSpPr/>
          <p:nvPr/>
        </p:nvSpPr>
        <p:spPr>
          <a:xfrm>
            <a:off x="4502655" y="3906169"/>
            <a:ext cx="179795" cy="57772"/>
          </a:xfrm>
          <a:prstGeom prst="lef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F9EFAF87-0A8F-665F-7E5C-359404329BF0}"/>
              </a:ext>
            </a:extLst>
          </p:cNvPr>
          <p:cNvSpPr txBox="1"/>
          <p:nvPr/>
        </p:nvSpPr>
        <p:spPr>
          <a:xfrm>
            <a:off x="1764449" y="1627222"/>
            <a:ext cx="507232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err="1"/>
              <a:t>Cont</a:t>
            </a:r>
            <a:endParaRPr lang="en-US" sz="1000" b="1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E98E00AE-1FCF-939A-051E-6AB2DBEE348E}"/>
              </a:ext>
            </a:extLst>
          </p:cNvPr>
          <p:cNvSpPr txBox="1"/>
          <p:nvPr/>
        </p:nvSpPr>
        <p:spPr>
          <a:xfrm>
            <a:off x="2588997" y="1627222"/>
            <a:ext cx="507232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/>
              <a:t>HFD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8D37E735-50BF-ACC8-1220-EA57F401A738}"/>
              </a:ext>
            </a:extLst>
          </p:cNvPr>
          <p:cNvSpPr txBox="1"/>
          <p:nvPr/>
        </p:nvSpPr>
        <p:spPr>
          <a:xfrm>
            <a:off x="3314641" y="1626156"/>
            <a:ext cx="507232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err="1"/>
              <a:t>Cont</a:t>
            </a:r>
            <a:endParaRPr lang="en-US" sz="1000" b="1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E706E49F-FD3A-A71C-FB10-FEB2A7F41448}"/>
              </a:ext>
            </a:extLst>
          </p:cNvPr>
          <p:cNvSpPr txBox="1"/>
          <p:nvPr/>
        </p:nvSpPr>
        <p:spPr>
          <a:xfrm>
            <a:off x="4139189" y="1626156"/>
            <a:ext cx="507232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/>
              <a:t>HFD</a:t>
            </a: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92C44A7A-306A-3CC4-903A-795063EB3E66}"/>
              </a:ext>
            </a:extLst>
          </p:cNvPr>
          <p:cNvSpPr/>
          <p:nvPr/>
        </p:nvSpPr>
        <p:spPr>
          <a:xfrm>
            <a:off x="4062038" y="2035416"/>
            <a:ext cx="714111" cy="160398"/>
          </a:xfrm>
          <a:prstGeom prst="rect">
            <a:avLst/>
          </a:prstGeom>
          <a:noFill/>
          <a:ln w="12700">
            <a:solidFill>
              <a:srgbClr val="0070C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62174532-94F2-C0BD-0FAF-D9998E7970AA}"/>
              </a:ext>
            </a:extLst>
          </p:cNvPr>
          <p:cNvSpPr/>
          <p:nvPr/>
        </p:nvSpPr>
        <p:spPr>
          <a:xfrm>
            <a:off x="2781775" y="2035416"/>
            <a:ext cx="547420" cy="144938"/>
          </a:xfrm>
          <a:prstGeom prst="rect">
            <a:avLst/>
          </a:prstGeom>
          <a:noFill/>
          <a:ln w="12700">
            <a:solidFill>
              <a:srgbClr val="0070C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E00A4E0F-19B7-D7AB-40C7-A8E28146127B}"/>
              </a:ext>
            </a:extLst>
          </p:cNvPr>
          <p:cNvSpPr/>
          <p:nvPr/>
        </p:nvSpPr>
        <p:spPr>
          <a:xfrm>
            <a:off x="3872525" y="3853581"/>
            <a:ext cx="545210" cy="203309"/>
          </a:xfrm>
          <a:prstGeom prst="rect">
            <a:avLst/>
          </a:prstGeom>
          <a:noFill/>
          <a:ln w="12700">
            <a:solidFill>
              <a:srgbClr val="0070C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0D233D08-EB71-6B53-AA05-99C7DF26772F}"/>
              </a:ext>
            </a:extLst>
          </p:cNvPr>
          <p:cNvSpPr/>
          <p:nvPr/>
        </p:nvSpPr>
        <p:spPr>
          <a:xfrm>
            <a:off x="2781775" y="3842167"/>
            <a:ext cx="545210" cy="203309"/>
          </a:xfrm>
          <a:prstGeom prst="rect">
            <a:avLst/>
          </a:prstGeom>
          <a:noFill/>
          <a:ln w="12700">
            <a:solidFill>
              <a:srgbClr val="0070C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F0B891F-57C9-1B6D-ACAD-544DD0D051AF}"/>
              </a:ext>
            </a:extLst>
          </p:cNvPr>
          <p:cNvSpPr txBox="1"/>
          <p:nvPr/>
        </p:nvSpPr>
        <p:spPr>
          <a:xfrm>
            <a:off x="3135127" y="1145409"/>
            <a:ext cx="477760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err="1"/>
              <a:t>iWAT</a:t>
            </a:r>
            <a:r>
              <a:rPr lang="en-US" sz="1000" b="1" dirty="0"/>
              <a:t> 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8C35DAE-3276-F00D-ECB2-DED23D506C8E}"/>
              </a:ext>
            </a:extLst>
          </p:cNvPr>
          <p:cNvSpPr txBox="1"/>
          <p:nvPr/>
        </p:nvSpPr>
        <p:spPr>
          <a:xfrm>
            <a:off x="142299" y="4348499"/>
            <a:ext cx="1683884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b="1" dirty="0"/>
              <a:t>Supplemental Figure 5J. 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7C13272C-3FF8-E584-D280-D53120BD75B3}"/>
              </a:ext>
            </a:extLst>
          </p:cNvPr>
          <p:cNvSpPr txBox="1"/>
          <p:nvPr/>
        </p:nvSpPr>
        <p:spPr>
          <a:xfrm>
            <a:off x="2709960" y="4831093"/>
            <a:ext cx="14369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Skeletal muscle</a:t>
            </a:r>
          </a:p>
        </p:txBody>
      </p:sp>
      <p:pic>
        <p:nvPicPr>
          <p:cNvPr id="39" name="Picture 38">
            <a:extLst>
              <a:ext uri="{FF2B5EF4-FFF2-40B4-BE49-F238E27FC236}">
                <a16:creationId xmlns:a16="http://schemas.microsoft.com/office/drawing/2014/main" id="{EA84D390-3A81-6A0D-8271-C6B8A275FBDB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5893" t="5088" r="8507" b="7778"/>
          <a:stretch/>
        </p:blipFill>
        <p:spPr>
          <a:xfrm>
            <a:off x="1168302" y="5277180"/>
            <a:ext cx="3632063" cy="539505"/>
          </a:xfrm>
          <a:prstGeom prst="rect">
            <a:avLst/>
          </a:prstGeom>
          <a:ln>
            <a:noFill/>
          </a:ln>
        </p:spPr>
      </p:pic>
      <p:sp>
        <p:nvSpPr>
          <p:cNvPr id="43" name="TextBox 42">
            <a:extLst>
              <a:ext uri="{FF2B5EF4-FFF2-40B4-BE49-F238E27FC236}">
                <a16:creationId xmlns:a16="http://schemas.microsoft.com/office/drawing/2014/main" id="{ED09FA16-DB2A-4EB8-BEB5-AE19E16C8FA6}"/>
              </a:ext>
            </a:extLst>
          </p:cNvPr>
          <p:cNvSpPr txBox="1"/>
          <p:nvPr/>
        </p:nvSpPr>
        <p:spPr>
          <a:xfrm>
            <a:off x="1561729" y="5136324"/>
            <a:ext cx="401844" cy="246220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/>
              <a:t>WT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128767E8-87E3-6678-FB95-4FD354FB01B5}"/>
              </a:ext>
            </a:extLst>
          </p:cNvPr>
          <p:cNvSpPr txBox="1"/>
          <p:nvPr/>
        </p:nvSpPr>
        <p:spPr>
          <a:xfrm>
            <a:off x="2320198" y="5118577"/>
            <a:ext cx="460873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/>
              <a:t>KO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F62F7E7D-ED50-ECA3-4889-10723ECD7AB3}"/>
              </a:ext>
            </a:extLst>
          </p:cNvPr>
          <p:cNvSpPr txBox="1"/>
          <p:nvPr/>
        </p:nvSpPr>
        <p:spPr>
          <a:xfrm>
            <a:off x="4837328" y="5355213"/>
            <a:ext cx="592809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/>
              <a:t>Serca1a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77BE7982-3505-F1A0-0E98-30C5BA6A7926}"/>
              </a:ext>
            </a:extLst>
          </p:cNvPr>
          <p:cNvSpPr txBox="1"/>
          <p:nvPr/>
        </p:nvSpPr>
        <p:spPr>
          <a:xfrm>
            <a:off x="4796021" y="5831135"/>
            <a:ext cx="635583" cy="400110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/>
              <a:t>Ponceau Red</a:t>
            </a:r>
          </a:p>
        </p:txBody>
      </p:sp>
      <p:pic>
        <p:nvPicPr>
          <p:cNvPr id="56" name="Picture 55">
            <a:extLst>
              <a:ext uri="{FF2B5EF4-FFF2-40B4-BE49-F238E27FC236}">
                <a16:creationId xmlns:a16="http://schemas.microsoft.com/office/drawing/2014/main" id="{99240152-01D6-7DDC-09CA-F769789CC4D0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4081" t="3621" r="7116" b="3874"/>
          <a:stretch/>
        </p:blipFill>
        <p:spPr>
          <a:xfrm>
            <a:off x="1203413" y="5852177"/>
            <a:ext cx="3632063" cy="1371479"/>
          </a:xfrm>
          <a:prstGeom prst="rect">
            <a:avLst/>
          </a:prstGeom>
          <a:ln>
            <a:noFill/>
          </a:ln>
        </p:spPr>
      </p:pic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9D28D551-D8BB-5924-B1BA-CB069DE54469}"/>
              </a:ext>
            </a:extLst>
          </p:cNvPr>
          <p:cNvCxnSpPr>
            <a:cxnSpLocks/>
          </p:cNvCxnSpPr>
          <p:nvPr/>
        </p:nvCxnSpPr>
        <p:spPr>
          <a:xfrm>
            <a:off x="2201505" y="5355213"/>
            <a:ext cx="0" cy="187086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Rectangle 57">
            <a:extLst>
              <a:ext uri="{FF2B5EF4-FFF2-40B4-BE49-F238E27FC236}">
                <a16:creationId xmlns:a16="http://schemas.microsoft.com/office/drawing/2014/main" id="{9A5E995D-D578-D5A7-0234-331AE43DE869}"/>
              </a:ext>
            </a:extLst>
          </p:cNvPr>
          <p:cNvSpPr/>
          <p:nvPr/>
        </p:nvSpPr>
        <p:spPr>
          <a:xfrm>
            <a:off x="1561729" y="5472110"/>
            <a:ext cx="313789" cy="129324"/>
          </a:xfrm>
          <a:prstGeom prst="rect">
            <a:avLst/>
          </a:prstGeom>
          <a:noFill/>
          <a:ln w="12700">
            <a:solidFill>
              <a:srgbClr val="0070C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8E71E06F-521A-357A-D391-833403CEA25B}"/>
              </a:ext>
            </a:extLst>
          </p:cNvPr>
          <p:cNvSpPr/>
          <p:nvPr/>
        </p:nvSpPr>
        <p:spPr>
          <a:xfrm>
            <a:off x="1612051" y="6207928"/>
            <a:ext cx="351517" cy="452373"/>
          </a:xfrm>
          <a:prstGeom prst="rect">
            <a:avLst/>
          </a:prstGeom>
          <a:noFill/>
          <a:ln w="12700">
            <a:solidFill>
              <a:srgbClr val="0070C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60" name="Left Arrow 59">
            <a:extLst>
              <a:ext uri="{FF2B5EF4-FFF2-40B4-BE49-F238E27FC236}">
                <a16:creationId xmlns:a16="http://schemas.microsoft.com/office/drawing/2014/main" id="{436CAA78-40A5-80E8-FABE-DDCCE00267EF}"/>
              </a:ext>
            </a:extLst>
          </p:cNvPr>
          <p:cNvSpPr/>
          <p:nvPr/>
        </p:nvSpPr>
        <p:spPr>
          <a:xfrm>
            <a:off x="4584109" y="5449437"/>
            <a:ext cx="179795" cy="57772"/>
          </a:xfrm>
          <a:prstGeom prst="lef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5E508B4B-3A4D-CC56-93EB-8A3E0CCA977B}"/>
              </a:ext>
            </a:extLst>
          </p:cNvPr>
          <p:cNvSpPr/>
          <p:nvPr/>
        </p:nvSpPr>
        <p:spPr>
          <a:xfrm>
            <a:off x="2480769" y="5445120"/>
            <a:ext cx="313789" cy="129324"/>
          </a:xfrm>
          <a:prstGeom prst="rect">
            <a:avLst/>
          </a:prstGeom>
          <a:noFill/>
          <a:ln w="12700">
            <a:solidFill>
              <a:srgbClr val="0070C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id="{63F7CC97-28D6-D702-F42D-9EB2C343191E}"/>
              </a:ext>
            </a:extLst>
          </p:cNvPr>
          <p:cNvSpPr/>
          <p:nvPr/>
        </p:nvSpPr>
        <p:spPr>
          <a:xfrm>
            <a:off x="2523199" y="6207928"/>
            <a:ext cx="351517" cy="452373"/>
          </a:xfrm>
          <a:prstGeom prst="rect">
            <a:avLst/>
          </a:prstGeom>
          <a:noFill/>
          <a:ln w="12700">
            <a:solidFill>
              <a:srgbClr val="0070C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</p:spTree>
    <p:extLst>
      <p:ext uri="{BB962C8B-B14F-4D97-AF65-F5344CB8AC3E}">
        <p14:creationId xmlns:p14="http://schemas.microsoft.com/office/powerpoint/2010/main" val="34421581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675</TotalTime>
  <Words>43</Words>
  <Application>Microsoft Macintosh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mbert, Renata P</dc:creator>
  <cp:lastModifiedBy>Alambert, Renata P</cp:lastModifiedBy>
  <cp:revision>22</cp:revision>
  <dcterms:created xsi:type="dcterms:W3CDTF">2023-01-04T15:24:52Z</dcterms:created>
  <dcterms:modified xsi:type="dcterms:W3CDTF">2023-07-24T23:32:27Z</dcterms:modified>
</cp:coreProperties>
</file>